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293" r:id="rId2"/>
    <p:sldId id="292" r:id="rId3"/>
    <p:sldId id="291" r:id="rId4"/>
  </p:sldIdLst>
  <p:sldSz cx="9144000" cy="6858000" type="screen4x3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196">
          <p15:clr>
            <a:srgbClr val="A4A3A4"/>
          </p15:clr>
        </p15:guide>
        <p15:guide id="2" orient="horz" pos="1131">
          <p15:clr>
            <a:srgbClr val="A4A3A4"/>
          </p15:clr>
        </p15:guide>
        <p15:guide id="3" orient="horz" pos="3559">
          <p15:clr>
            <a:srgbClr val="A4A3A4"/>
          </p15:clr>
        </p15:guide>
        <p15:guide id="4" orient="horz" pos="1854">
          <p15:clr>
            <a:srgbClr val="A4A3A4"/>
          </p15:clr>
        </p15:guide>
        <p15:guide id="5" pos="318">
          <p15:clr>
            <a:srgbClr val="A4A3A4"/>
          </p15:clr>
        </p15:guide>
        <p15:guide id="6" pos="1248">
          <p15:clr>
            <a:srgbClr val="A4A3A4"/>
          </p15:clr>
        </p15:guide>
        <p15:guide id="7" pos="2225">
          <p15:clr>
            <a:srgbClr val="A4A3A4"/>
          </p15:clr>
        </p15:guide>
        <p15:guide id="8" pos="401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ndrea Matros" initials="AM" lastIdx="18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5828"/>
    <a:srgbClr val="F3F7FB"/>
    <a:srgbClr val="CFDDED"/>
    <a:srgbClr val="E3F3D1"/>
    <a:srgbClr val="FFFFD5"/>
    <a:srgbClr val="FFFF97"/>
    <a:srgbClr val="BDD292"/>
    <a:srgbClr val="FFE48F"/>
    <a:srgbClr val="6EA92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137" autoAdjust="0"/>
    <p:restoredTop sz="94743" autoAdjust="0"/>
  </p:normalViewPr>
  <p:slideViewPr>
    <p:cSldViewPr snapToGrid="0" showGuides="1">
      <p:cViewPr varScale="1">
        <p:scale>
          <a:sx n="110" d="100"/>
          <a:sy n="110" d="100"/>
        </p:scale>
        <p:origin x="1728" y="108"/>
      </p:cViewPr>
      <p:guideLst>
        <p:guide orient="horz" pos="4196"/>
        <p:guide orient="horz" pos="1131"/>
        <p:guide orient="horz" pos="3559"/>
        <p:guide orient="horz" pos="1854"/>
        <p:guide pos="318"/>
        <p:guide pos="1248"/>
        <p:guide pos="2225"/>
        <p:guide pos="401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openxmlformats.org/officeDocument/2006/relationships/tableStyles" Target="tableStyles.xml"/><Relationship Id="rId5" Type="http://schemas.openxmlformats.org/officeDocument/2006/relationships/notesMaster" Target="notesMasters/notesMaster1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50444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A475AA-5291-4217-88C3-8FB05BCDB050}" type="datetimeFigureOut">
              <a:rPr lang="en-GB" smtClean="0"/>
              <a:pPr/>
              <a:t>25/07/2017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1" y="9378826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50444" y="9378826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C9D2A7-09C7-493D-856F-3E9D3112D715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580559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40DC62-2C7D-4960-8FC2-21DFC7FE58A1}" type="datetimeFigureOut">
              <a:rPr lang="en-GB" smtClean="0"/>
              <a:pPr/>
              <a:t>25/07/2017</a:t>
            </a:fld>
            <a:endParaRPr lang="en-GB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30275" y="741363"/>
            <a:ext cx="4937125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690272"/>
            <a:ext cx="5438140" cy="44434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9378826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4" y="9378826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ADA2F9-781B-47FA-A34A-043B6E7C3A0F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04580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9BCC7-CD49-4D9C-9445-06E5D5614969}" type="datetimeFigureOut">
              <a:rPr lang="en-GB" smtClean="0"/>
              <a:pPr/>
              <a:t>25/07/2017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DAC16-32EB-48E1-A513-F4C85DA29CA1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9BCC7-CD49-4D9C-9445-06E5D5614969}" type="datetimeFigureOut">
              <a:rPr lang="en-GB" smtClean="0"/>
              <a:pPr/>
              <a:t>25/07/2017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DAC16-32EB-48E1-A513-F4C85DA29CA1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9BCC7-CD49-4D9C-9445-06E5D5614969}" type="datetimeFigureOut">
              <a:rPr lang="en-GB" smtClean="0"/>
              <a:pPr/>
              <a:t>25/07/2017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DAC16-32EB-48E1-A513-F4C85DA29CA1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9BCC7-CD49-4D9C-9445-06E5D5614969}" type="datetimeFigureOut">
              <a:rPr lang="en-GB" smtClean="0"/>
              <a:pPr/>
              <a:t>25/07/2017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DAC16-32EB-48E1-A513-F4C85DA29CA1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9BCC7-CD49-4D9C-9445-06E5D5614969}" type="datetimeFigureOut">
              <a:rPr lang="en-GB" smtClean="0"/>
              <a:pPr/>
              <a:t>25/07/2017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DAC16-32EB-48E1-A513-F4C85DA29CA1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9BCC7-CD49-4D9C-9445-06E5D5614969}" type="datetimeFigureOut">
              <a:rPr lang="en-GB" smtClean="0"/>
              <a:pPr/>
              <a:t>25/07/2017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DAC16-32EB-48E1-A513-F4C85DA29CA1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9BCC7-CD49-4D9C-9445-06E5D5614969}" type="datetimeFigureOut">
              <a:rPr lang="en-GB" smtClean="0"/>
              <a:pPr/>
              <a:t>25/07/2017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DAC16-32EB-48E1-A513-F4C85DA29CA1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9BCC7-CD49-4D9C-9445-06E5D5614969}" type="datetimeFigureOut">
              <a:rPr lang="en-GB" smtClean="0"/>
              <a:pPr/>
              <a:t>25/07/2017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DAC16-32EB-48E1-A513-F4C85DA29CA1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9BCC7-CD49-4D9C-9445-06E5D5614969}" type="datetimeFigureOut">
              <a:rPr lang="en-GB" smtClean="0"/>
              <a:pPr/>
              <a:t>25/07/2017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DAC16-32EB-48E1-A513-F4C85DA29CA1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9BCC7-CD49-4D9C-9445-06E5D5614969}" type="datetimeFigureOut">
              <a:rPr lang="en-GB" smtClean="0"/>
              <a:pPr/>
              <a:t>25/07/2017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DAC16-32EB-48E1-A513-F4C85DA29CA1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9BCC7-CD49-4D9C-9445-06E5D5614969}" type="datetimeFigureOut">
              <a:rPr lang="en-GB" smtClean="0"/>
              <a:pPr/>
              <a:t>25/07/2017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DAC16-32EB-48E1-A513-F4C85DA29CA1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F9BCC7-CD49-4D9C-9445-06E5D5614969}" type="datetimeFigureOut">
              <a:rPr lang="en-GB" smtClean="0"/>
              <a:pPr/>
              <a:t>25/07/2017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5DAC16-32EB-48E1-A513-F4C85DA29CA1}" type="slidenum">
              <a:rPr lang="en-GB" smtClean="0"/>
              <a:pPr/>
              <a:t>‹Nr.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0552" y="1213160"/>
            <a:ext cx="8514078" cy="18074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72833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1143" y="293298"/>
            <a:ext cx="3363053" cy="6198273"/>
          </a:xfrm>
          <a:prstGeom prst="rect">
            <a:avLst/>
          </a:prstGeom>
        </p:spPr>
      </p:pic>
      <p:sp>
        <p:nvSpPr>
          <p:cNvPr id="6" name="Rechteck 5"/>
          <p:cNvSpPr/>
          <p:nvPr/>
        </p:nvSpPr>
        <p:spPr>
          <a:xfrm>
            <a:off x="4244196" y="1852890"/>
            <a:ext cx="4572000" cy="107721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. S2, Starch and free sugars in developing grains of lines S12i and S80i, (means ± SD, n=3), significant differences according to t-test, *, P &lt; 0.05, **, P &lt; 0.01, ***, P &lt; 0.001.</a:t>
            </a:r>
          </a:p>
        </p:txBody>
      </p:sp>
    </p:spTree>
    <p:extLst>
      <p:ext uri="{BB962C8B-B14F-4D97-AF65-F5344CB8AC3E}">
        <p14:creationId xmlns:p14="http://schemas.microsoft.com/office/powerpoint/2010/main" val="8881659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038" name="Picture 6"/>
          <p:cNvPicPr>
            <a:picLocks noChangeAspect="1" noChangeArrowheads="1"/>
          </p:cNvPicPr>
          <p:nvPr/>
        </p:nvPicPr>
        <p:blipFill>
          <a:blip r:embed="rId2" cstate="print"/>
          <a:srcRect t="5007"/>
          <a:stretch>
            <a:fillRect/>
          </a:stretch>
        </p:blipFill>
        <p:spPr bwMode="auto">
          <a:xfrm>
            <a:off x="299554" y="261426"/>
            <a:ext cx="5849004" cy="6279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" name="Textfeld 9"/>
          <p:cNvSpPr txBox="1"/>
          <p:nvPr/>
        </p:nvSpPr>
        <p:spPr>
          <a:xfrm>
            <a:off x="2486025" y="6372225"/>
            <a:ext cx="14302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Days after flowering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 rot="16200000">
            <a:off x="-666751" y="3038475"/>
            <a:ext cx="19495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Free amino acids (µmol g</a:t>
            </a:r>
            <a:r>
              <a:rPr lang="en-GB" sz="1100" baseline="26000" dirty="0" smtClean="0">
                <a:latin typeface="Arial" pitchFamily="34" charset="0"/>
                <a:cs typeface="Arial" pitchFamily="34" charset="0"/>
              </a:rPr>
              <a:t>-1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)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Rechteck 1"/>
          <p:cNvSpPr/>
          <p:nvPr/>
        </p:nvSpPr>
        <p:spPr>
          <a:xfrm>
            <a:off x="6582392" y="2967335"/>
            <a:ext cx="203835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bsolute amino acid contents determined by UPLC in endosperm of S20i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red symbols) and wild-type (black symbols)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9</Words>
  <Application>Microsoft Office PowerPoint</Application>
  <PresentationFormat>Bildschirmpräsentation (4:3)</PresentationFormat>
  <Paragraphs>4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6" baseType="lpstr">
      <vt:lpstr>Arial</vt:lpstr>
      <vt:lpstr>Calibri</vt:lpstr>
      <vt:lpstr>Larissa-Design</vt:lpstr>
      <vt:lpstr>PowerPoint-Präsentation</vt:lpstr>
      <vt:lpstr>PowerPoint-Präsentation</vt:lpstr>
      <vt:lpstr>PowerPoint-Präsentation</vt:lpstr>
    </vt:vector>
  </TitlesOfParts>
  <Company>IPK Gaterslebe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radchukv</dc:creator>
  <cp:lastModifiedBy>Hans Weber</cp:lastModifiedBy>
  <cp:revision>506</cp:revision>
  <cp:lastPrinted>2017-01-05T08:20:10Z</cp:lastPrinted>
  <dcterms:created xsi:type="dcterms:W3CDTF">2013-09-02T08:58:54Z</dcterms:created>
  <dcterms:modified xsi:type="dcterms:W3CDTF">2017-07-25T08:29:39Z</dcterms:modified>
</cp:coreProperties>
</file>